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20" r:id="rId1"/>
  </p:sldMasterIdLst>
  <p:sldIdLst>
    <p:sldId id="257" r:id="rId2"/>
  </p:sldIdLst>
  <p:sldSz cx="10333038" cy="2925763"/>
  <p:notesSz cx="6858000" cy="9144000"/>
  <p:defaultTextStyle>
    <a:defPPr>
      <a:defRPr lang="en-US"/>
    </a:defPPr>
    <a:lvl1pPr marL="0" algn="l" defTabSz="649431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1pPr>
    <a:lvl2pPr marL="324714" algn="l" defTabSz="649431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2pPr>
    <a:lvl3pPr marL="649431" algn="l" defTabSz="649431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3pPr>
    <a:lvl4pPr marL="974145" algn="l" defTabSz="649431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4pPr>
    <a:lvl5pPr marL="1298860" algn="l" defTabSz="649431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5pPr>
    <a:lvl6pPr marL="1623574" algn="l" defTabSz="649431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6pPr>
    <a:lvl7pPr marL="1948288" algn="l" defTabSz="649431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7pPr>
    <a:lvl8pPr marL="2273005" algn="l" defTabSz="649431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8pPr>
    <a:lvl9pPr marL="2597720" algn="l" defTabSz="649431" rtl="0" eaLnBrk="1" latinLnBrk="0" hangingPunct="1">
      <a:defRPr sz="1278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612"/>
    <p:restoredTop sz="94643"/>
  </p:normalViewPr>
  <p:slideViewPr>
    <p:cSldViewPr snapToGrid="0" snapToObjects="1">
      <p:cViewPr varScale="1">
        <p:scale>
          <a:sx n="140" d="100"/>
          <a:sy n="140" d="100"/>
        </p:scale>
        <p:origin x="208" y="16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GoogleDrive/My%20Drive/Research/2_Buell%20Lab_MSU/*USDA_BRAG/ALS1%20trangenic%20lines_RNAseq/RNAseq/RNAseq%20data/8_als1%20allele%20frequency/als1%20allele%20frequenc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GoogleDrive/My%20Drive/Research/2_Buell%20Lab_MSU/*USDA_BRAG/ALS1%20trangenic%20lines_RNAseq/RNAseq/RNAseq%20data/8_als1%20allele%20frequency/als1%20allele%20frequency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GoogleDrive/My%20Drive/Research/2_Buell%20Lab_MSU/*USDA_BRAG/ALS1%20trangenic%20lines_RNAseq/RNAseq/RNAseq%20data/8_als1%20allele%20frequency/als1%20allele%20frequency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/GoogleDrive/My%20Drive/Research/2_Buell%20Lab_MSU/*USDA_BRAG/ALS1%20trangenic%20lines_RNAseq/RNAseq/RNAseq%20data/8_als1%20allele%20frequency/als1%20allele%20frequency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rgbClr val="0432FF"/>
            </a:solidFill>
            <a:ln>
              <a:noFill/>
            </a:ln>
            <a:effectLst/>
          </c:spPr>
          <c:invertIfNegative val="0"/>
          <c:dPt>
            <c:idx val="3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E093-CF42-86AB-9551031F0F68}"/>
              </c:ext>
            </c:extLst>
          </c:dPt>
          <c:errBars>
            <c:errBarType val="both"/>
            <c:errValType val="cust"/>
            <c:noEndCap val="0"/>
            <c:plus>
              <c:numRef>
                <c:f>'v3 (vmatch)'!$B$48:$B$53</c:f>
                <c:numCache>
                  <c:formatCode>General</c:formatCode>
                  <c:ptCount val="6"/>
                  <c:pt idx="0">
                    <c:v>4.6296296296296138E-3</c:v>
                  </c:pt>
                  <c:pt idx="1">
                    <c:v>5.1335010788597486E-2</c:v>
                  </c:pt>
                  <c:pt idx="2">
                    <c:v>8.5523343314507175E-3</c:v>
                  </c:pt>
                  <c:pt idx="3">
                    <c:v>2.4319213574024175E-2</c:v>
                  </c:pt>
                  <c:pt idx="4">
                    <c:v>1.17502558635008E-2</c:v>
                  </c:pt>
                  <c:pt idx="5">
                    <c:v>2.406783500843937E-2</c:v>
                  </c:pt>
                </c:numCache>
              </c:numRef>
            </c:plus>
            <c:minus>
              <c:numRef>
                <c:f>'v3 (vmatch)'!$B$48:$B$53</c:f>
                <c:numCache>
                  <c:formatCode>General</c:formatCode>
                  <c:ptCount val="6"/>
                  <c:pt idx="0">
                    <c:v>4.6296296296296138E-3</c:v>
                  </c:pt>
                  <c:pt idx="1">
                    <c:v>5.1335010788597486E-2</c:v>
                  </c:pt>
                  <c:pt idx="2">
                    <c:v>8.5523343314507175E-3</c:v>
                  </c:pt>
                  <c:pt idx="3">
                    <c:v>2.4319213574024175E-2</c:v>
                  </c:pt>
                  <c:pt idx="4">
                    <c:v>1.17502558635008E-2</c:v>
                  </c:pt>
                  <c:pt idx="5">
                    <c:v>2.406783500843937E-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v3 (vmatch)'!$A$41:$A$46</c:f>
              <c:strCache>
                <c:ptCount val="6"/>
                <c:pt idx="0">
                  <c:v>WT</c:v>
                </c:pt>
                <c:pt idx="1">
                  <c:v>als1-1a</c:v>
                </c:pt>
                <c:pt idx="2">
                  <c:v>als1-10a</c:v>
                </c:pt>
                <c:pt idx="3">
                  <c:v>als1-15a</c:v>
                </c:pt>
                <c:pt idx="4">
                  <c:v>als1-17</c:v>
                </c:pt>
                <c:pt idx="5">
                  <c:v>als1-26</c:v>
                </c:pt>
              </c:strCache>
            </c:strRef>
          </c:cat>
          <c:val>
            <c:numRef>
              <c:f>'v3 (vmatch)'!$B$41:$B$46</c:f>
              <c:numCache>
                <c:formatCode>General</c:formatCode>
                <c:ptCount val="6"/>
                <c:pt idx="0">
                  <c:v>0.99537037037037035</c:v>
                </c:pt>
                <c:pt idx="1">
                  <c:v>0.71241147103216063</c:v>
                </c:pt>
                <c:pt idx="2">
                  <c:v>0.77924035964280547</c:v>
                </c:pt>
                <c:pt idx="3">
                  <c:v>0.86802864605757912</c:v>
                </c:pt>
                <c:pt idx="4">
                  <c:v>0.90252600120257431</c:v>
                </c:pt>
                <c:pt idx="5">
                  <c:v>0.82772090976425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093-CF42-86AB-9551031F0F68}"/>
            </c:ext>
          </c:extLst>
        </c:ser>
        <c:ser>
          <c:idx val="1"/>
          <c:order val="1"/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v3 (vmatch)'!$C$48:$C$53</c:f>
                <c:numCache>
                  <c:formatCode>General</c:formatCode>
                  <c:ptCount val="6"/>
                  <c:pt idx="0">
                    <c:v>4.6296296296296302E-3</c:v>
                  </c:pt>
                  <c:pt idx="1">
                    <c:v>5.1335010788597216E-2</c:v>
                  </c:pt>
                  <c:pt idx="2">
                    <c:v>8.5523343314507089E-3</c:v>
                  </c:pt>
                  <c:pt idx="3">
                    <c:v>2.4319213574024223E-2</c:v>
                  </c:pt>
                  <c:pt idx="4">
                    <c:v>1.1750255863500767E-2</c:v>
                  </c:pt>
                  <c:pt idx="5">
                    <c:v>2.4067835008439422E-2</c:v>
                  </c:pt>
                </c:numCache>
              </c:numRef>
            </c:plus>
            <c:minus>
              <c:numRef>
                <c:f>'v3 (vmatch)'!$C$48:$C$53</c:f>
                <c:numCache>
                  <c:formatCode>General</c:formatCode>
                  <c:ptCount val="6"/>
                  <c:pt idx="0">
                    <c:v>4.6296296296296302E-3</c:v>
                  </c:pt>
                  <c:pt idx="1">
                    <c:v>5.1335010788597216E-2</c:v>
                  </c:pt>
                  <c:pt idx="2">
                    <c:v>8.5523343314507089E-3</c:v>
                  </c:pt>
                  <c:pt idx="3">
                    <c:v>2.4319213574024223E-2</c:v>
                  </c:pt>
                  <c:pt idx="4">
                    <c:v>1.1750255863500767E-2</c:v>
                  </c:pt>
                  <c:pt idx="5">
                    <c:v>2.4067835008439422E-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v3 (vmatch)'!$A$41:$A$46</c:f>
              <c:strCache>
                <c:ptCount val="6"/>
                <c:pt idx="0">
                  <c:v>WT</c:v>
                </c:pt>
                <c:pt idx="1">
                  <c:v>als1-1a</c:v>
                </c:pt>
                <c:pt idx="2">
                  <c:v>als1-10a</c:v>
                </c:pt>
                <c:pt idx="3">
                  <c:v>als1-15a</c:v>
                </c:pt>
                <c:pt idx="4">
                  <c:v>als1-17</c:v>
                </c:pt>
                <c:pt idx="5">
                  <c:v>als1-26</c:v>
                </c:pt>
              </c:strCache>
            </c:strRef>
          </c:cat>
          <c:val>
            <c:numRef>
              <c:f>'v3 (vmatch)'!$C$41:$C$46</c:f>
              <c:numCache>
                <c:formatCode>General</c:formatCode>
                <c:ptCount val="6"/>
                <c:pt idx="0">
                  <c:v>4.6296296296296294E-3</c:v>
                </c:pt>
                <c:pt idx="1">
                  <c:v>0.28758852896783932</c:v>
                </c:pt>
                <c:pt idx="2">
                  <c:v>0.22075964035719456</c:v>
                </c:pt>
                <c:pt idx="3">
                  <c:v>0.13197135394242085</c:v>
                </c:pt>
                <c:pt idx="4">
                  <c:v>9.7473998797425784E-2</c:v>
                </c:pt>
                <c:pt idx="5">
                  <c:v>0.172279090235746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093-CF42-86AB-9551031F0F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36213951"/>
        <c:axId val="336161039"/>
      </c:barChart>
      <c:catAx>
        <c:axId val="336213951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36161039"/>
        <c:crosses val="autoZero"/>
        <c:auto val="1"/>
        <c:lblAlgn val="ctr"/>
        <c:lblOffset val="100"/>
        <c:noMultiLvlLbl val="0"/>
      </c:catAx>
      <c:valAx>
        <c:axId val="33616103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362139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rgbClr val="0432FF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v3 (vmatch)'!$F$48:$F$5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5.6880922169106687E-3</c:v>
                  </c:pt>
                  <c:pt idx="2">
                    <c:v>4.0276589389797737E-2</c:v>
                  </c:pt>
                  <c:pt idx="3">
                    <c:v>1.1384991170708198E-2</c:v>
                  </c:pt>
                  <c:pt idx="4">
                    <c:v>2.5638279044123181E-2</c:v>
                  </c:pt>
                  <c:pt idx="5">
                    <c:v>1.6535627524638521E-2</c:v>
                  </c:pt>
                </c:numCache>
              </c:numRef>
            </c:plus>
            <c:minus>
              <c:numRef>
                <c:f>'v3 (vmatch)'!$F$48:$F$5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5.6880922169106687E-3</c:v>
                  </c:pt>
                  <c:pt idx="2">
                    <c:v>4.0276589389797737E-2</c:v>
                  </c:pt>
                  <c:pt idx="3">
                    <c:v>1.1384991170708198E-2</c:v>
                  </c:pt>
                  <c:pt idx="4">
                    <c:v>2.5638279044123181E-2</c:v>
                  </c:pt>
                  <c:pt idx="5">
                    <c:v>1.6535627524638521E-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v3 (vmatch)'!$A$41:$A$46</c:f>
              <c:strCache>
                <c:ptCount val="6"/>
                <c:pt idx="0">
                  <c:v>WT</c:v>
                </c:pt>
                <c:pt idx="1">
                  <c:v>als1-1a</c:v>
                </c:pt>
                <c:pt idx="2">
                  <c:v>als1-10a</c:v>
                </c:pt>
                <c:pt idx="3">
                  <c:v>als1-15a</c:v>
                </c:pt>
                <c:pt idx="4">
                  <c:v>als1-17</c:v>
                </c:pt>
                <c:pt idx="5">
                  <c:v>als1-26</c:v>
                </c:pt>
              </c:strCache>
            </c:strRef>
          </c:cat>
          <c:val>
            <c:numRef>
              <c:f>'v3 (vmatch)'!$F$41:$F$46</c:f>
              <c:numCache>
                <c:formatCode>General</c:formatCode>
                <c:ptCount val="6"/>
                <c:pt idx="0">
                  <c:v>1</c:v>
                </c:pt>
                <c:pt idx="1">
                  <c:v>0.64070467954500676</c:v>
                </c:pt>
                <c:pt idx="2">
                  <c:v>0.58717620354579159</c:v>
                </c:pt>
                <c:pt idx="3">
                  <c:v>0.7261472039516389</c:v>
                </c:pt>
                <c:pt idx="4">
                  <c:v>0.82596484271741988</c:v>
                </c:pt>
                <c:pt idx="5">
                  <c:v>0.683202294191305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AF8-9A4A-A6BC-EC2B0AD673B7}"/>
            </c:ext>
          </c:extLst>
        </c:ser>
        <c:ser>
          <c:idx val="1"/>
          <c:order val="1"/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v3 (vmatch)'!$G$48:$G$5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5.6880922169106575E-3</c:v>
                  </c:pt>
                  <c:pt idx="2">
                    <c:v>4.02765893897978E-2</c:v>
                  </c:pt>
                  <c:pt idx="3">
                    <c:v>1.1384991170708193E-2</c:v>
                  </c:pt>
                  <c:pt idx="4">
                    <c:v>2.5638279044123167E-2</c:v>
                  </c:pt>
                  <c:pt idx="5">
                    <c:v>1.6535627524638517E-2</c:v>
                  </c:pt>
                </c:numCache>
              </c:numRef>
            </c:plus>
            <c:minus>
              <c:numRef>
                <c:f>'v3 (vmatch)'!$G$48:$G$5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5.6880922169106575E-3</c:v>
                  </c:pt>
                  <c:pt idx="2">
                    <c:v>4.02765893897978E-2</c:v>
                  </c:pt>
                  <c:pt idx="3">
                    <c:v>1.1384991170708193E-2</c:v>
                  </c:pt>
                  <c:pt idx="4">
                    <c:v>2.5638279044123167E-2</c:v>
                  </c:pt>
                  <c:pt idx="5">
                    <c:v>1.6535627524638517E-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v3 (vmatch)'!$A$41:$A$46</c:f>
              <c:strCache>
                <c:ptCount val="6"/>
                <c:pt idx="0">
                  <c:v>WT</c:v>
                </c:pt>
                <c:pt idx="1">
                  <c:v>als1-1a</c:v>
                </c:pt>
                <c:pt idx="2">
                  <c:v>als1-10a</c:v>
                </c:pt>
                <c:pt idx="3">
                  <c:v>als1-15a</c:v>
                </c:pt>
                <c:pt idx="4">
                  <c:v>als1-17</c:v>
                </c:pt>
                <c:pt idx="5">
                  <c:v>als1-26</c:v>
                </c:pt>
              </c:strCache>
            </c:strRef>
          </c:cat>
          <c:val>
            <c:numRef>
              <c:f>'v3 (vmatch)'!$G$41:$G$46</c:f>
              <c:numCache>
                <c:formatCode>General</c:formatCode>
                <c:ptCount val="6"/>
                <c:pt idx="0">
                  <c:v>0</c:v>
                </c:pt>
                <c:pt idx="1">
                  <c:v>0.35929532045499318</c:v>
                </c:pt>
                <c:pt idx="2">
                  <c:v>0.41282379645420852</c:v>
                </c:pt>
                <c:pt idx="3">
                  <c:v>0.27385279604836105</c:v>
                </c:pt>
                <c:pt idx="4">
                  <c:v>0.17403515728257998</c:v>
                </c:pt>
                <c:pt idx="5">
                  <c:v>0.316797705808694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AF8-9A4A-A6BC-EC2B0AD673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17054847"/>
        <c:axId val="416757679"/>
      </c:barChart>
      <c:catAx>
        <c:axId val="417054847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16757679"/>
        <c:crosses val="autoZero"/>
        <c:auto val="1"/>
        <c:lblAlgn val="ctr"/>
        <c:lblOffset val="100"/>
        <c:noMultiLvlLbl val="0"/>
      </c:catAx>
      <c:valAx>
        <c:axId val="41675767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1705484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spPr>
            <a:solidFill>
              <a:srgbClr val="0000FF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v3 (vmatch)'!$D$48:$D$5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4.9960350870326332E-2</c:v>
                  </c:pt>
                  <c:pt idx="2">
                    <c:v>1.7501617885429678E-2</c:v>
                  </c:pt>
                  <c:pt idx="3">
                    <c:v>8.6411673829077645E-3</c:v>
                  </c:pt>
                  <c:pt idx="4">
                    <c:v>1.739579269233249E-2</c:v>
                  </c:pt>
                  <c:pt idx="5">
                    <c:v>1.0277042661393267E-2</c:v>
                  </c:pt>
                </c:numCache>
              </c:numRef>
            </c:plus>
            <c:minus>
              <c:numRef>
                <c:f>'v3 (vmatch)'!$D$48:$D$5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4.9960350870326332E-2</c:v>
                  </c:pt>
                  <c:pt idx="2">
                    <c:v>1.7501617885429678E-2</c:v>
                  </c:pt>
                  <c:pt idx="3">
                    <c:v>8.6411673829077645E-3</c:v>
                  </c:pt>
                  <c:pt idx="4">
                    <c:v>1.739579269233249E-2</c:v>
                  </c:pt>
                  <c:pt idx="5">
                    <c:v>1.027704266139326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v3 (vmatch)'!$A$41:$A$46</c:f>
              <c:strCache>
                <c:ptCount val="6"/>
                <c:pt idx="0">
                  <c:v>WT</c:v>
                </c:pt>
                <c:pt idx="1">
                  <c:v>als1-1a</c:v>
                </c:pt>
                <c:pt idx="2">
                  <c:v>als1-10a</c:v>
                </c:pt>
                <c:pt idx="3">
                  <c:v>als1-15a</c:v>
                </c:pt>
                <c:pt idx="4">
                  <c:v>als1-17</c:v>
                </c:pt>
                <c:pt idx="5">
                  <c:v>als1-26</c:v>
                </c:pt>
              </c:strCache>
            </c:strRef>
          </c:cat>
          <c:val>
            <c:numRef>
              <c:f>'v3 (vmatch)'!$D$41:$D$46</c:f>
              <c:numCache>
                <c:formatCode>General</c:formatCode>
                <c:ptCount val="6"/>
                <c:pt idx="0">
                  <c:v>1</c:v>
                </c:pt>
                <c:pt idx="1">
                  <c:v>0.69793185678714531</c:v>
                </c:pt>
                <c:pt idx="2">
                  <c:v>0.74680430959500732</c:v>
                </c:pt>
                <c:pt idx="3">
                  <c:v>0.83420307077596079</c:v>
                </c:pt>
                <c:pt idx="4">
                  <c:v>0.93080609253709901</c:v>
                </c:pt>
                <c:pt idx="5">
                  <c:v>0.829853925805392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2BB-D541-9CE3-F7EAD7C7D16C}"/>
            </c:ext>
          </c:extLst>
        </c:ser>
        <c:ser>
          <c:idx val="1"/>
          <c:order val="1"/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v3 (vmatch)'!$E$48:$E$5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4.996035087032679E-2</c:v>
                  </c:pt>
                  <c:pt idx="2">
                    <c:v>1.7501617885429661E-2</c:v>
                  </c:pt>
                  <c:pt idx="3">
                    <c:v>8.6411673829077801E-3</c:v>
                  </c:pt>
                  <c:pt idx="4">
                    <c:v>1.7395792692332494E-2</c:v>
                  </c:pt>
                  <c:pt idx="5">
                    <c:v>1.0277042661393274E-2</c:v>
                  </c:pt>
                </c:numCache>
              </c:numRef>
            </c:plus>
            <c:minus>
              <c:numRef>
                <c:f>'v3 (vmatch)'!$E$48:$E$5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4.996035087032679E-2</c:v>
                  </c:pt>
                  <c:pt idx="2">
                    <c:v>1.7501617885429661E-2</c:v>
                  </c:pt>
                  <c:pt idx="3">
                    <c:v>8.6411673829077801E-3</c:v>
                  </c:pt>
                  <c:pt idx="4">
                    <c:v>1.7395792692332494E-2</c:v>
                  </c:pt>
                  <c:pt idx="5">
                    <c:v>1.0277042661393274E-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v3 (vmatch)'!$A$41:$A$46</c:f>
              <c:strCache>
                <c:ptCount val="6"/>
                <c:pt idx="0">
                  <c:v>WT</c:v>
                </c:pt>
                <c:pt idx="1">
                  <c:v>als1-1a</c:v>
                </c:pt>
                <c:pt idx="2">
                  <c:v>als1-10a</c:v>
                </c:pt>
                <c:pt idx="3">
                  <c:v>als1-15a</c:v>
                </c:pt>
                <c:pt idx="4">
                  <c:v>als1-17</c:v>
                </c:pt>
                <c:pt idx="5">
                  <c:v>als1-26</c:v>
                </c:pt>
              </c:strCache>
            </c:strRef>
          </c:cat>
          <c:val>
            <c:numRef>
              <c:f>'v3 (vmatch)'!$E$41:$E$46</c:f>
              <c:numCache>
                <c:formatCode>General</c:formatCode>
                <c:ptCount val="6"/>
                <c:pt idx="0">
                  <c:v>0</c:v>
                </c:pt>
                <c:pt idx="1">
                  <c:v>0.30206814321285475</c:v>
                </c:pt>
                <c:pt idx="2">
                  <c:v>0.25319569040499273</c:v>
                </c:pt>
                <c:pt idx="3">
                  <c:v>0.16579692922403921</c:v>
                </c:pt>
                <c:pt idx="4">
                  <c:v>6.9193907462900939E-2</c:v>
                </c:pt>
                <c:pt idx="5">
                  <c:v>0.170146074194607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2BB-D541-9CE3-F7EAD7C7D1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12039439"/>
        <c:axId val="411998207"/>
      </c:barChart>
      <c:catAx>
        <c:axId val="412039439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11998207"/>
        <c:crosses val="autoZero"/>
        <c:auto val="1"/>
        <c:lblAlgn val="ctr"/>
        <c:lblOffset val="100"/>
        <c:noMultiLvlLbl val="0"/>
      </c:catAx>
      <c:valAx>
        <c:axId val="41199820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in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120394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spPr>
            <a:solidFill>
              <a:srgbClr val="0432FF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v3 (vmatch)'!$H$48:$H$53</c:f>
                <c:numCache>
                  <c:formatCode>General</c:formatCode>
                  <c:ptCount val="6"/>
                  <c:pt idx="0">
                    <c:v>1.1534025374856003E-3</c:v>
                  </c:pt>
                  <c:pt idx="1">
                    <c:v>1.8820793539380987E-2</c:v>
                  </c:pt>
                  <c:pt idx="2">
                    <c:v>8.7896984679986193E-3</c:v>
                  </c:pt>
                  <c:pt idx="3">
                    <c:v>4.0644712277662408E-3</c:v>
                  </c:pt>
                  <c:pt idx="4">
                    <c:v>1.0604330881472014E-2</c:v>
                  </c:pt>
                  <c:pt idx="5">
                    <c:v>3.7379904817970246E-3</c:v>
                  </c:pt>
                </c:numCache>
              </c:numRef>
            </c:plus>
            <c:minus>
              <c:numRef>
                <c:f>'v3 (vmatch)'!$H$48:$H$53</c:f>
                <c:numCache>
                  <c:formatCode>General</c:formatCode>
                  <c:ptCount val="6"/>
                  <c:pt idx="0">
                    <c:v>1.1534025374856003E-3</c:v>
                  </c:pt>
                  <c:pt idx="1">
                    <c:v>1.8820793539380987E-2</c:v>
                  </c:pt>
                  <c:pt idx="2">
                    <c:v>8.7896984679986193E-3</c:v>
                  </c:pt>
                  <c:pt idx="3">
                    <c:v>4.0644712277662408E-3</c:v>
                  </c:pt>
                  <c:pt idx="4">
                    <c:v>1.0604330881472014E-2</c:v>
                  </c:pt>
                  <c:pt idx="5">
                    <c:v>3.737990481797024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v3 (vmatch)'!$A$41:$A$46</c:f>
              <c:strCache>
                <c:ptCount val="6"/>
                <c:pt idx="0">
                  <c:v>WT</c:v>
                </c:pt>
                <c:pt idx="1">
                  <c:v>als1-1a</c:v>
                </c:pt>
                <c:pt idx="2">
                  <c:v>als1-10a</c:v>
                </c:pt>
                <c:pt idx="3">
                  <c:v>als1-15a</c:v>
                </c:pt>
                <c:pt idx="4">
                  <c:v>als1-17</c:v>
                </c:pt>
                <c:pt idx="5">
                  <c:v>als1-26</c:v>
                </c:pt>
              </c:strCache>
            </c:strRef>
          </c:cat>
          <c:val>
            <c:numRef>
              <c:f>'v3 (vmatch)'!$H$41:$H$46</c:f>
              <c:numCache>
                <c:formatCode>General</c:formatCode>
                <c:ptCount val="6"/>
                <c:pt idx="0">
                  <c:v>0.99884659746251447</c:v>
                </c:pt>
                <c:pt idx="1">
                  <c:v>0.75614877908604605</c:v>
                </c:pt>
                <c:pt idx="2">
                  <c:v>0.7951197725169431</c:v>
                </c:pt>
                <c:pt idx="3">
                  <c:v>0.85997257154686124</c:v>
                </c:pt>
                <c:pt idx="4">
                  <c:v>0.92807455705533959</c:v>
                </c:pt>
                <c:pt idx="5">
                  <c:v>0.846485068943104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30C-8443-9119-A3F4C73823A0}"/>
            </c:ext>
          </c:extLst>
        </c:ser>
        <c:ser>
          <c:idx val="1"/>
          <c:order val="1"/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v3 (vmatch)'!$I$48:$I$53</c:f>
                <c:numCache>
                  <c:formatCode>General</c:formatCode>
                  <c:ptCount val="6"/>
                  <c:pt idx="0">
                    <c:v>1.1534025374855825E-3</c:v>
                  </c:pt>
                  <c:pt idx="1">
                    <c:v>1.8820793539381073E-2</c:v>
                  </c:pt>
                  <c:pt idx="2">
                    <c:v>8.7896984679986384E-3</c:v>
                  </c:pt>
                  <c:pt idx="3">
                    <c:v>4.0644712277662261E-3</c:v>
                  </c:pt>
                  <c:pt idx="4">
                    <c:v>1.0604330881471969E-2</c:v>
                  </c:pt>
                  <c:pt idx="5">
                    <c:v>3.7379904817970012E-3</c:v>
                  </c:pt>
                </c:numCache>
              </c:numRef>
            </c:plus>
            <c:minus>
              <c:numRef>
                <c:f>'v3 (vmatch)'!$I$48:$I$53</c:f>
                <c:numCache>
                  <c:formatCode>General</c:formatCode>
                  <c:ptCount val="6"/>
                  <c:pt idx="0">
                    <c:v>1.1534025374855825E-3</c:v>
                  </c:pt>
                  <c:pt idx="1">
                    <c:v>1.8820793539381073E-2</c:v>
                  </c:pt>
                  <c:pt idx="2">
                    <c:v>8.7896984679986384E-3</c:v>
                  </c:pt>
                  <c:pt idx="3">
                    <c:v>4.0644712277662261E-3</c:v>
                  </c:pt>
                  <c:pt idx="4">
                    <c:v>1.0604330881471969E-2</c:v>
                  </c:pt>
                  <c:pt idx="5">
                    <c:v>3.7379904817970012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v3 (vmatch)'!$A$41:$A$46</c:f>
              <c:strCache>
                <c:ptCount val="6"/>
                <c:pt idx="0">
                  <c:v>WT</c:v>
                </c:pt>
                <c:pt idx="1">
                  <c:v>als1-1a</c:v>
                </c:pt>
                <c:pt idx="2">
                  <c:v>als1-10a</c:v>
                </c:pt>
                <c:pt idx="3">
                  <c:v>als1-15a</c:v>
                </c:pt>
                <c:pt idx="4">
                  <c:v>als1-17</c:v>
                </c:pt>
                <c:pt idx="5">
                  <c:v>als1-26</c:v>
                </c:pt>
              </c:strCache>
            </c:strRef>
          </c:cat>
          <c:val>
            <c:numRef>
              <c:f>'v3 (vmatch)'!$I$41:$I$46</c:f>
              <c:numCache>
                <c:formatCode>General</c:formatCode>
                <c:ptCount val="6"/>
                <c:pt idx="0">
                  <c:v>1.1534025374855825E-3</c:v>
                </c:pt>
                <c:pt idx="1">
                  <c:v>0.24385122091395392</c:v>
                </c:pt>
                <c:pt idx="2">
                  <c:v>0.20488022748305693</c:v>
                </c:pt>
                <c:pt idx="3">
                  <c:v>0.14002742845313873</c:v>
                </c:pt>
                <c:pt idx="4">
                  <c:v>7.1925442944660523E-2</c:v>
                </c:pt>
                <c:pt idx="5">
                  <c:v>0.153514931056895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30C-8443-9119-A3F4C73823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051621344"/>
        <c:axId val="2051602176"/>
      </c:barChart>
      <c:catAx>
        <c:axId val="2051621344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51602176"/>
        <c:crosses val="autoZero"/>
        <c:auto val="1"/>
        <c:lblAlgn val="ctr"/>
        <c:lblOffset val="100"/>
        <c:noMultiLvlLbl val="0"/>
      </c:catAx>
      <c:valAx>
        <c:axId val="20516021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516213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91630" y="478823"/>
            <a:ext cx="7749779" cy="1018599"/>
          </a:xfrm>
        </p:spPr>
        <p:txBody>
          <a:bodyPr anchor="b"/>
          <a:lstStyle>
            <a:lvl1pPr algn="ctr"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91630" y="1536703"/>
            <a:ext cx="7749779" cy="706382"/>
          </a:xfrm>
        </p:spPr>
        <p:txBody>
          <a:bodyPr/>
          <a:lstStyle>
            <a:lvl1pPr marL="0" indent="0" algn="ctr">
              <a:buNone/>
              <a:defRPr sz="1024"/>
            </a:lvl1pPr>
            <a:lvl2pPr marL="195042" indent="0" algn="ctr">
              <a:buNone/>
              <a:defRPr sz="853"/>
            </a:lvl2pPr>
            <a:lvl3pPr marL="390083" indent="0" algn="ctr">
              <a:buNone/>
              <a:defRPr sz="768"/>
            </a:lvl3pPr>
            <a:lvl4pPr marL="585125" indent="0" algn="ctr">
              <a:buNone/>
              <a:defRPr sz="683"/>
            </a:lvl4pPr>
            <a:lvl5pPr marL="780166" indent="0" algn="ctr">
              <a:buNone/>
              <a:defRPr sz="683"/>
            </a:lvl5pPr>
            <a:lvl6pPr marL="975208" indent="0" algn="ctr">
              <a:buNone/>
              <a:defRPr sz="683"/>
            </a:lvl6pPr>
            <a:lvl7pPr marL="1170249" indent="0" algn="ctr">
              <a:buNone/>
              <a:defRPr sz="683"/>
            </a:lvl7pPr>
            <a:lvl8pPr marL="1365291" indent="0" algn="ctr">
              <a:buNone/>
              <a:defRPr sz="683"/>
            </a:lvl8pPr>
            <a:lvl9pPr marL="1560332" indent="0" algn="ctr">
              <a:buNone/>
              <a:defRPr sz="68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6D269-C57B-F749-AE24-148BB6C9676A}" type="datetimeFigureOut">
              <a:rPr lang="en-US" smtClean="0"/>
              <a:t>7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DBE97-4B17-D84E-894F-6DDC1F5F42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625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6D269-C57B-F749-AE24-148BB6C9676A}" type="datetimeFigureOut">
              <a:rPr lang="en-US" smtClean="0"/>
              <a:t>7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DBE97-4B17-D84E-894F-6DDC1F5F42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24918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394580" y="155770"/>
            <a:ext cx="2228061" cy="247944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10396" y="155770"/>
            <a:ext cx="6555021" cy="247944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6D269-C57B-F749-AE24-148BB6C9676A}" type="datetimeFigureOut">
              <a:rPr lang="en-US" smtClean="0"/>
              <a:t>7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DBE97-4B17-D84E-894F-6DDC1F5F42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447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6D269-C57B-F749-AE24-148BB6C9676A}" type="datetimeFigureOut">
              <a:rPr lang="en-US" smtClean="0"/>
              <a:t>7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DBE97-4B17-D84E-894F-6DDC1F5F42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91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5015" y="729409"/>
            <a:ext cx="8912245" cy="1217036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5015" y="1957959"/>
            <a:ext cx="8912245" cy="640010"/>
          </a:xfrm>
        </p:spPr>
        <p:txBody>
          <a:bodyPr/>
          <a:lstStyle>
            <a:lvl1pPr marL="0" indent="0">
              <a:buNone/>
              <a:defRPr sz="1024">
                <a:solidFill>
                  <a:schemeClr val="tx1">
                    <a:tint val="75000"/>
                  </a:schemeClr>
                </a:solidFill>
              </a:defRPr>
            </a:lvl1pPr>
            <a:lvl2pPr marL="195042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2pPr>
            <a:lvl3pPr marL="390083" indent="0">
              <a:buNone/>
              <a:defRPr sz="768">
                <a:solidFill>
                  <a:schemeClr val="tx1">
                    <a:tint val="75000"/>
                  </a:schemeClr>
                </a:solidFill>
              </a:defRPr>
            </a:lvl3pPr>
            <a:lvl4pPr marL="585125" indent="0">
              <a:buNone/>
              <a:defRPr sz="683">
                <a:solidFill>
                  <a:schemeClr val="tx1">
                    <a:tint val="75000"/>
                  </a:schemeClr>
                </a:solidFill>
              </a:defRPr>
            </a:lvl4pPr>
            <a:lvl5pPr marL="780166" indent="0">
              <a:buNone/>
              <a:defRPr sz="683">
                <a:solidFill>
                  <a:schemeClr val="tx1">
                    <a:tint val="75000"/>
                  </a:schemeClr>
                </a:solidFill>
              </a:defRPr>
            </a:lvl5pPr>
            <a:lvl6pPr marL="975208" indent="0">
              <a:buNone/>
              <a:defRPr sz="683">
                <a:solidFill>
                  <a:schemeClr val="tx1">
                    <a:tint val="75000"/>
                  </a:schemeClr>
                </a:solidFill>
              </a:defRPr>
            </a:lvl6pPr>
            <a:lvl7pPr marL="1170249" indent="0">
              <a:buNone/>
              <a:defRPr sz="683">
                <a:solidFill>
                  <a:schemeClr val="tx1">
                    <a:tint val="75000"/>
                  </a:schemeClr>
                </a:solidFill>
              </a:defRPr>
            </a:lvl7pPr>
            <a:lvl8pPr marL="1365291" indent="0">
              <a:buNone/>
              <a:defRPr sz="683">
                <a:solidFill>
                  <a:schemeClr val="tx1">
                    <a:tint val="75000"/>
                  </a:schemeClr>
                </a:solidFill>
              </a:defRPr>
            </a:lvl8pPr>
            <a:lvl9pPr marL="1560332" indent="0">
              <a:buNone/>
              <a:defRPr sz="68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6D269-C57B-F749-AE24-148BB6C9676A}" type="datetimeFigureOut">
              <a:rPr lang="en-US" smtClean="0"/>
              <a:t>7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DBE97-4B17-D84E-894F-6DDC1F5F42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112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10396" y="778849"/>
            <a:ext cx="4391541" cy="185637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31101" y="778849"/>
            <a:ext cx="4391541" cy="185637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6D269-C57B-F749-AE24-148BB6C9676A}" type="datetimeFigureOut">
              <a:rPr lang="en-US" smtClean="0"/>
              <a:t>7/3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DBE97-4B17-D84E-894F-6DDC1F5F42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22994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1742" y="155770"/>
            <a:ext cx="8912245" cy="56551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1743" y="717218"/>
            <a:ext cx="4371359" cy="351498"/>
          </a:xfrm>
        </p:spPr>
        <p:txBody>
          <a:bodyPr anchor="b"/>
          <a:lstStyle>
            <a:lvl1pPr marL="0" indent="0">
              <a:buNone/>
              <a:defRPr sz="1024" b="1"/>
            </a:lvl1pPr>
            <a:lvl2pPr marL="195042" indent="0">
              <a:buNone/>
              <a:defRPr sz="853" b="1"/>
            </a:lvl2pPr>
            <a:lvl3pPr marL="390083" indent="0">
              <a:buNone/>
              <a:defRPr sz="768" b="1"/>
            </a:lvl3pPr>
            <a:lvl4pPr marL="585125" indent="0">
              <a:buNone/>
              <a:defRPr sz="683" b="1"/>
            </a:lvl4pPr>
            <a:lvl5pPr marL="780166" indent="0">
              <a:buNone/>
              <a:defRPr sz="683" b="1"/>
            </a:lvl5pPr>
            <a:lvl6pPr marL="975208" indent="0">
              <a:buNone/>
              <a:defRPr sz="683" b="1"/>
            </a:lvl6pPr>
            <a:lvl7pPr marL="1170249" indent="0">
              <a:buNone/>
              <a:defRPr sz="683" b="1"/>
            </a:lvl7pPr>
            <a:lvl8pPr marL="1365291" indent="0">
              <a:buNone/>
              <a:defRPr sz="683" b="1"/>
            </a:lvl8pPr>
            <a:lvl9pPr marL="1560332" indent="0">
              <a:buNone/>
              <a:defRPr sz="68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11743" y="1068716"/>
            <a:ext cx="4371359" cy="157192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231100" y="717218"/>
            <a:ext cx="4392887" cy="351498"/>
          </a:xfrm>
        </p:spPr>
        <p:txBody>
          <a:bodyPr anchor="b"/>
          <a:lstStyle>
            <a:lvl1pPr marL="0" indent="0">
              <a:buNone/>
              <a:defRPr sz="1024" b="1"/>
            </a:lvl1pPr>
            <a:lvl2pPr marL="195042" indent="0">
              <a:buNone/>
              <a:defRPr sz="853" b="1"/>
            </a:lvl2pPr>
            <a:lvl3pPr marL="390083" indent="0">
              <a:buNone/>
              <a:defRPr sz="768" b="1"/>
            </a:lvl3pPr>
            <a:lvl4pPr marL="585125" indent="0">
              <a:buNone/>
              <a:defRPr sz="683" b="1"/>
            </a:lvl4pPr>
            <a:lvl5pPr marL="780166" indent="0">
              <a:buNone/>
              <a:defRPr sz="683" b="1"/>
            </a:lvl5pPr>
            <a:lvl6pPr marL="975208" indent="0">
              <a:buNone/>
              <a:defRPr sz="683" b="1"/>
            </a:lvl6pPr>
            <a:lvl7pPr marL="1170249" indent="0">
              <a:buNone/>
              <a:defRPr sz="683" b="1"/>
            </a:lvl7pPr>
            <a:lvl8pPr marL="1365291" indent="0">
              <a:buNone/>
              <a:defRPr sz="683" b="1"/>
            </a:lvl8pPr>
            <a:lvl9pPr marL="1560332" indent="0">
              <a:buNone/>
              <a:defRPr sz="68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231100" y="1068716"/>
            <a:ext cx="4392887" cy="157192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6D269-C57B-F749-AE24-148BB6C9676A}" type="datetimeFigureOut">
              <a:rPr lang="en-US" smtClean="0"/>
              <a:t>7/30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DBE97-4B17-D84E-894F-6DDC1F5F42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309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6D269-C57B-F749-AE24-148BB6C9676A}" type="datetimeFigureOut">
              <a:rPr lang="en-US" smtClean="0"/>
              <a:t>7/30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DBE97-4B17-D84E-894F-6DDC1F5F42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2204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6D269-C57B-F749-AE24-148BB6C9676A}" type="datetimeFigureOut">
              <a:rPr lang="en-US" smtClean="0"/>
              <a:t>7/30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DBE97-4B17-D84E-894F-6DDC1F5F42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045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1743" y="195051"/>
            <a:ext cx="3332673" cy="682678"/>
          </a:xfrm>
        </p:spPr>
        <p:txBody>
          <a:bodyPr anchor="b"/>
          <a:lstStyle>
            <a:lvl1pPr>
              <a:defRPr sz="136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392887" y="421256"/>
            <a:ext cx="5231100" cy="2079188"/>
          </a:xfrm>
        </p:spPr>
        <p:txBody>
          <a:bodyPr/>
          <a:lstStyle>
            <a:lvl1pPr>
              <a:defRPr sz="1365"/>
            </a:lvl1pPr>
            <a:lvl2pPr>
              <a:defRPr sz="1194"/>
            </a:lvl2pPr>
            <a:lvl3pPr>
              <a:defRPr sz="1024"/>
            </a:lvl3pPr>
            <a:lvl4pPr>
              <a:defRPr sz="853"/>
            </a:lvl4pPr>
            <a:lvl5pPr>
              <a:defRPr sz="853"/>
            </a:lvl5pPr>
            <a:lvl6pPr>
              <a:defRPr sz="853"/>
            </a:lvl6pPr>
            <a:lvl7pPr>
              <a:defRPr sz="853"/>
            </a:lvl7pPr>
            <a:lvl8pPr>
              <a:defRPr sz="853"/>
            </a:lvl8pPr>
            <a:lvl9pPr>
              <a:defRPr sz="853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1743" y="877729"/>
            <a:ext cx="3332673" cy="1626101"/>
          </a:xfrm>
        </p:spPr>
        <p:txBody>
          <a:bodyPr/>
          <a:lstStyle>
            <a:lvl1pPr marL="0" indent="0">
              <a:buNone/>
              <a:defRPr sz="683"/>
            </a:lvl1pPr>
            <a:lvl2pPr marL="195042" indent="0">
              <a:buNone/>
              <a:defRPr sz="597"/>
            </a:lvl2pPr>
            <a:lvl3pPr marL="390083" indent="0">
              <a:buNone/>
              <a:defRPr sz="512"/>
            </a:lvl3pPr>
            <a:lvl4pPr marL="585125" indent="0">
              <a:buNone/>
              <a:defRPr sz="427"/>
            </a:lvl4pPr>
            <a:lvl5pPr marL="780166" indent="0">
              <a:buNone/>
              <a:defRPr sz="427"/>
            </a:lvl5pPr>
            <a:lvl6pPr marL="975208" indent="0">
              <a:buNone/>
              <a:defRPr sz="427"/>
            </a:lvl6pPr>
            <a:lvl7pPr marL="1170249" indent="0">
              <a:buNone/>
              <a:defRPr sz="427"/>
            </a:lvl7pPr>
            <a:lvl8pPr marL="1365291" indent="0">
              <a:buNone/>
              <a:defRPr sz="427"/>
            </a:lvl8pPr>
            <a:lvl9pPr marL="1560332" indent="0">
              <a:buNone/>
              <a:defRPr sz="42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6D269-C57B-F749-AE24-148BB6C9676A}" type="datetimeFigureOut">
              <a:rPr lang="en-US" smtClean="0"/>
              <a:t>7/3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DBE97-4B17-D84E-894F-6DDC1F5F42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125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1743" y="195051"/>
            <a:ext cx="3332673" cy="682678"/>
          </a:xfrm>
        </p:spPr>
        <p:txBody>
          <a:bodyPr anchor="b"/>
          <a:lstStyle>
            <a:lvl1pPr>
              <a:defRPr sz="136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392887" y="421256"/>
            <a:ext cx="5231100" cy="2079188"/>
          </a:xfrm>
        </p:spPr>
        <p:txBody>
          <a:bodyPr anchor="t"/>
          <a:lstStyle>
            <a:lvl1pPr marL="0" indent="0">
              <a:buNone/>
              <a:defRPr sz="1365"/>
            </a:lvl1pPr>
            <a:lvl2pPr marL="195042" indent="0">
              <a:buNone/>
              <a:defRPr sz="1194"/>
            </a:lvl2pPr>
            <a:lvl3pPr marL="390083" indent="0">
              <a:buNone/>
              <a:defRPr sz="1024"/>
            </a:lvl3pPr>
            <a:lvl4pPr marL="585125" indent="0">
              <a:buNone/>
              <a:defRPr sz="853"/>
            </a:lvl4pPr>
            <a:lvl5pPr marL="780166" indent="0">
              <a:buNone/>
              <a:defRPr sz="853"/>
            </a:lvl5pPr>
            <a:lvl6pPr marL="975208" indent="0">
              <a:buNone/>
              <a:defRPr sz="853"/>
            </a:lvl6pPr>
            <a:lvl7pPr marL="1170249" indent="0">
              <a:buNone/>
              <a:defRPr sz="853"/>
            </a:lvl7pPr>
            <a:lvl8pPr marL="1365291" indent="0">
              <a:buNone/>
              <a:defRPr sz="853"/>
            </a:lvl8pPr>
            <a:lvl9pPr marL="1560332" indent="0">
              <a:buNone/>
              <a:defRPr sz="85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1743" y="877729"/>
            <a:ext cx="3332673" cy="1626101"/>
          </a:xfrm>
        </p:spPr>
        <p:txBody>
          <a:bodyPr/>
          <a:lstStyle>
            <a:lvl1pPr marL="0" indent="0">
              <a:buNone/>
              <a:defRPr sz="683"/>
            </a:lvl1pPr>
            <a:lvl2pPr marL="195042" indent="0">
              <a:buNone/>
              <a:defRPr sz="597"/>
            </a:lvl2pPr>
            <a:lvl3pPr marL="390083" indent="0">
              <a:buNone/>
              <a:defRPr sz="512"/>
            </a:lvl3pPr>
            <a:lvl4pPr marL="585125" indent="0">
              <a:buNone/>
              <a:defRPr sz="427"/>
            </a:lvl4pPr>
            <a:lvl5pPr marL="780166" indent="0">
              <a:buNone/>
              <a:defRPr sz="427"/>
            </a:lvl5pPr>
            <a:lvl6pPr marL="975208" indent="0">
              <a:buNone/>
              <a:defRPr sz="427"/>
            </a:lvl6pPr>
            <a:lvl7pPr marL="1170249" indent="0">
              <a:buNone/>
              <a:defRPr sz="427"/>
            </a:lvl7pPr>
            <a:lvl8pPr marL="1365291" indent="0">
              <a:buNone/>
              <a:defRPr sz="427"/>
            </a:lvl8pPr>
            <a:lvl9pPr marL="1560332" indent="0">
              <a:buNone/>
              <a:defRPr sz="42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6D269-C57B-F749-AE24-148BB6C9676A}" type="datetimeFigureOut">
              <a:rPr lang="en-US" smtClean="0"/>
              <a:t>7/3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DBE97-4B17-D84E-894F-6DDC1F5F42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4777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10397" y="155770"/>
            <a:ext cx="8912245" cy="5655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0397" y="778849"/>
            <a:ext cx="8912245" cy="18563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10396" y="2711749"/>
            <a:ext cx="2324934" cy="1557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1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D6D269-C57B-F749-AE24-148BB6C9676A}" type="datetimeFigureOut">
              <a:rPr lang="en-US" smtClean="0"/>
              <a:t>7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22819" y="2711749"/>
            <a:ext cx="3487400" cy="1557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1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97708" y="2711749"/>
            <a:ext cx="2324934" cy="1557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1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DDBE97-4B17-D84E-894F-6DDC1F5F42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3622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390083" rtl="0" eaLnBrk="1" latinLnBrk="0" hangingPunct="1">
        <a:lnSpc>
          <a:spcPct val="90000"/>
        </a:lnSpc>
        <a:spcBef>
          <a:spcPct val="0"/>
        </a:spcBef>
        <a:buNone/>
        <a:defRPr sz="187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7521" indent="-97521" algn="l" defTabSz="390083" rtl="0" eaLnBrk="1" latinLnBrk="0" hangingPunct="1">
        <a:lnSpc>
          <a:spcPct val="90000"/>
        </a:lnSpc>
        <a:spcBef>
          <a:spcPts val="427"/>
        </a:spcBef>
        <a:buFont typeface="Arial" panose="020B0604020202020204" pitchFamily="34" charset="0"/>
        <a:buChar char="•"/>
        <a:defRPr sz="1194" kern="1200">
          <a:solidFill>
            <a:schemeClr val="tx1"/>
          </a:solidFill>
          <a:latin typeface="+mn-lt"/>
          <a:ea typeface="+mn-ea"/>
          <a:cs typeface="+mn-cs"/>
        </a:defRPr>
      </a:lvl1pPr>
      <a:lvl2pPr marL="292562" indent="-97521" algn="l" defTabSz="390083" rtl="0" eaLnBrk="1" latinLnBrk="0" hangingPunct="1">
        <a:lnSpc>
          <a:spcPct val="90000"/>
        </a:lnSpc>
        <a:spcBef>
          <a:spcPts val="213"/>
        </a:spcBef>
        <a:buFont typeface="Arial" panose="020B0604020202020204" pitchFamily="34" charset="0"/>
        <a:buChar char="•"/>
        <a:defRPr sz="1024" kern="1200">
          <a:solidFill>
            <a:schemeClr val="tx1"/>
          </a:solidFill>
          <a:latin typeface="+mn-lt"/>
          <a:ea typeface="+mn-ea"/>
          <a:cs typeface="+mn-cs"/>
        </a:defRPr>
      </a:lvl2pPr>
      <a:lvl3pPr marL="487604" indent="-97521" algn="l" defTabSz="390083" rtl="0" eaLnBrk="1" latinLnBrk="0" hangingPunct="1">
        <a:lnSpc>
          <a:spcPct val="90000"/>
        </a:lnSpc>
        <a:spcBef>
          <a:spcPts val="213"/>
        </a:spcBef>
        <a:buFont typeface="Arial" panose="020B0604020202020204" pitchFamily="34" charset="0"/>
        <a:buChar char="•"/>
        <a:defRPr sz="853" kern="1200">
          <a:solidFill>
            <a:schemeClr val="tx1"/>
          </a:solidFill>
          <a:latin typeface="+mn-lt"/>
          <a:ea typeface="+mn-ea"/>
          <a:cs typeface="+mn-cs"/>
        </a:defRPr>
      </a:lvl3pPr>
      <a:lvl4pPr marL="682645" indent="-97521" algn="l" defTabSz="390083" rtl="0" eaLnBrk="1" latinLnBrk="0" hangingPunct="1">
        <a:lnSpc>
          <a:spcPct val="90000"/>
        </a:lnSpc>
        <a:spcBef>
          <a:spcPts val="213"/>
        </a:spcBef>
        <a:buFont typeface="Arial" panose="020B0604020202020204" pitchFamily="34" charset="0"/>
        <a:buChar char="•"/>
        <a:defRPr sz="768" kern="1200">
          <a:solidFill>
            <a:schemeClr val="tx1"/>
          </a:solidFill>
          <a:latin typeface="+mn-lt"/>
          <a:ea typeface="+mn-ea"/>
          <a:cs typeface="+mn-cs"/>
        </a:defRPr>
      </a:lvl4pPr>
      <a:lvl5pPr marL="877687" indent="-97521" algn="l" defTabSz="390083" rtl="0" eaLnBrk="1" latinLnBrk="0" hangingPunct="1">
        <a:lnSpc>
          <a:spcPct val="90000"/>
        </a:lnSpc>
        <a:spcBef>
          <a:spcPts val="213"/>
        </a:spcBef>
        <a:buFont typeface="Arial" panose="020B0604020202020204" pitchFamily="34" charset="0"/>
        <a:buChar char="•"/>
        <a:defRPr sz="768" kern="1200">
          <a:solidFill>
            <a:schemeClr val="tx1"/>
          </a:solidFill>
          <a:latin typeface="+mn-lt"/>
          <a:ea typeface="+mn-ea"/>
          <a:cs typeface="+mn-cs"/>
        </a:defRPr>
      </a:lvl5pPr>
      <a:lvl6pPr marL="1072728" indent="-97521" algn="l" defTabSz="390083" rtl="0" eaLnBrk="1" latinLnBrk="0" hangingPunct="1">
        <a:lnSpc>
          <a:spcPct val="90000"/>
        </a:lnSpc>
        <a:spcBef>
          <a:spcPts val="213"/>
        </a:spcBef>
        <a:buFont typeface="Arial" panose="020B0604020202020204" pitchFamily="34" charset="0"/>
        <a:buChar char="•"/>
        <a:defRPr sz="768" kern="1200">
          <a:solidFill>
            <a:schemeClr val="tx1"/>
          </a:solidFill>
          <a:latin typeface="+mn-lt"/>
          <a:ea typeface="+mn-ea"/>
          <a:cs typeface="+mn-cs"/>
        </a:defRPr>
      </a:lvl6pPr>
      <a:lvl7pPr marL="1267770" indent="-97521" algn="l" defTabSz="390083" rtl="0" eaLnBrk="1" latinLnBrk="0" hangingPunct="1">
        <a:lnSpc>
          <a:spcPct val="90000"/>
        </a:lnSpc>
        <a:spcBef>
          <a:spcPts val="213"/>
        </a:spcBef>
        <a:buFont typeface="Arial" panose="020B0604020202020204" pitchFamily="34" charset="0"/>
        <a:buChar char="•"/>
        <a:defRPr sz="768" kern="1200">
          <a:solidFill>
            <a:schemeClr val="tx1"/>
          </a:solidFill>
          <a:latin typeface="+mn-lt"/>
          <a:ea typeface="+mn-ea"/>
          <a:cs typeface="+mn-cs"/>
        </a:defRPr>
      </a:lvl7pPr>
      <a:lvl8pPr marL="1462811" indent="-97521" algn="l" defTabSz="390083" rtl="0" eaLnBrk="1" latinLnBrk="0" hangingPunct="1">
        <a:lnSpc>
          <a:spcPct val="90000"/>
        </a:lnSpc>
        <a:spcBef>
          <a:spcPts val="213"/>
        </a:spcBef>
        <a:buFont typeface="Arial" panose="020B0604020202020204" pitchFamily="34" charset="0"/>
        <a:buChar char="•"/>
        <a:defRPr sz="768" kern="1200">
          <a:solidFill>
            <a:schemeClr val="tx1"/>
          </a:solidFill>
          <a:latin typeface="+mn-lt"/>
          <a:ea typeface="+mn-ea"/>
          <a:cs typeface="+mn-cs"/>
        </a:defRPr>
      </a:lvl8pPr>
      <a:lvl9pPr marL="1657853" indent="-97521" algn="l" defTabSz="390083" rtl="0" eaLnBrk="1" latinLnBrk="0" hangingPunct="1">
        <a:lnSpc>
          <a:spcPct val="90000"/>
        </a:lnSpc>
        <a:spcBef>
          <a:spcPts val="213"/>
        </a:spcBef>
        <a:buFont typeface="Arial" panose="020B0604020202020204" pitchFamily="34" charset="0"/>
        <a:buChar char="•"/>
        <a:defRPr sz="76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90083" rtl="0" eaLnBrk="1" latinLnBrk="0" hangingPunct="1">
        <a:defRPr sz="768" kern="1200">
          <a:solidFill>
            <a:schemeClr val="tx1"/>
          </a:solidFill>
          <a:latin typeface="+mn-lt"/>
          <a:ea typeface="+mn-ea"/>
          <a:cs typeface="+mn-cs"/>
        </a:defRPr>
      </a:lvl1pPr>
      <a:lvl2pPr marL="195042" algn="l" defTabSz="390083" rtl="0" eaLnBrk="1" latinLnBrk="0" hangingPunct="1">
        <a:defRPr sz="768" kern="1200">
          <a:solidFill>
            <a:schemeClr val="tx1"/>
          </a:solidFill>
          <a:latin typeface="+mn-lt"/>
          <a:ea typeface="+mn-ea"/>
          <a:cs typeface="+mn-cs"/>
        </a:defRPr>
      </a:lvl2pPr>
      <a:lvl3pPr marL="390083" algn="l" defTabSz="390083" rtl="0" eaLnBrk="1" latinLnBrk="0" hangingPunct="1">
        <a:defRPr sz="768" kern="1200">
          <a:solidFill>
            <a:schemeClr val="tx1"/>
          </a:solidFill>
          <a:latin typeface="+mn-lt"/>
          <a:ea typeface="+mn-ea"/>
          <a:cs typeface="+mn-cs"/>
        </a:defRPr>
      </a:lvl3pPr>
      <a:lvl4pPr marL="585125" algn="l" defTabSz="390083" rtl="0" eaLnBrk="1" latinLnBrk="0" hangingPunct="1">
        <a:defRPr sz="768" kern="1200">
          <a:solidFill>
            <a:schemeClr val="tx1"/>
          </a:solidFill>
          <a:latin typeface="+mn-lt"/>
          <a:ea typeface="+mn-ea"/>
          <a:cs typeface="+mn-cs"/>
        </a:defRPr>
      </a:lvl4pPr>
      <a:lvl5pPr marL="780166" algn="l" defTabSz="390083" rtl="0" eaLnBrk="1" latinLnBrk="0" hangingPunct="1">
        <a:defRPr sz="768" kern="1200">
          <a:solidFill>
            <a:schemeClr val="tx1"/>
          </a:solidFill>
          <a:latin typeface="+mn-lt"/>
          <a:ea typeface="+mn-ea"/>
          <a:cs typeface="+mn-cs"/>
        </a:defRPr>
      </a:lvl5pPr>
      <a:lvl6pPr marL="975208" algn="l" defTabSz="390083" rtl="0" eaLnBrk="1" latinLnBrk="0" hangingPunct="1">
        <a:defRPr sz="768" kern="1200">
          <a:solidFill>
            <a:schemeClr val="tx1"/>
          </a:solidFill>
          <a:latin typeface="+mn-lt"/>
          <a:ea typeface="+mn-ea"/>
          <a:cs typeface="+mn-cs"/>
        </a:defRPr>
      </a:lvl6pPr>
      <a:lvl7pPr marL="1170249" algn="l" defTabSz="390083" rtl="0" eaLnBrk="1" latinLnBrk="0" hangingPunct="1">
        <a:defRPr sz="768" kern="1200">
          <a:solidFill>
            <a:schemeClr val="tx1"/>
          </a:solidFill>
          <a:latin typeface="+mn-lt"/>
          <a:ea typeface="+mn-ea"/>
          <a:cs typeface="+mn-cs"/>
        </a:defRPr>
      </a:lvl7pPr>
      <a:lvl8pPr marL="1365291" algn="l" defTabSz="390083" rtl="0" eaLnBrk="1" latinLnBrk="0" hangingPunct="1">
        <a:defRPr sz="768" kern="1200">
          <a:solidFill>
            <a:schemeClr val="tx1"/>
          </a:solidFill>
          <a:latin typeface="+mn-lt"/>
          <a:ea typeface="+mn-ea"/>
          <a:cs typeface="+mn-cs"/>
        </a:defRPr>
      </a:lvl8pPr>
      <a:lvl9pPr marL="1560332" algn="l" defTabSz="390083" rtl="0" eaLnBrk="1" latinLnBrk="0" hangingPunct="1">
        <a:defRPr sz="76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50168D86-17B2-334F-92DD-32A44DC25E69}"/>
              </a:ext>
            </a:extLst>
          </p:cNvPr>
          <p:cNvCxnSpPr/>
          <p:nvPr/>
        </p:nvCxnSpPr>
        <p:spPr>
          <a:xfrm flipH="1">
            <a:off x="4472882" y="261186"/>
            <a:ext cx="0" cy="10972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B273E82F-7011-7640-9140-F0EF4A99CE29}"/>
              </a:ext>
            </a:extLst>
          </p:cNvPr>
          <p:cNvCxnSpPr/>
          <p:nvPr/>
        </p:nvCxnSpPr>
        <p:spPr>
          <a:xfrm flipH="1">
            <a:off x="4764524" y="261186"/>
            <a:ext cx="0" cy="21031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F3ABBEC8-D4C9-D747-883F-8FC14737F2CB}"/>
              </a:ext>
            </a:extLst>
          </p:cNvPr>
          <p:cNvCxnSpPr/>
          <p:nvPr/>
        </p:nvCxnSpPr>
        <p:spPr>
          <a:xfrm flipH="1">
            <a:off x="5689208" y="261186"/>
            <a:ext cx="0" cy="10972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C2A92ABD-BBF6-0248-9EF2-790D725BEA62}"/>
              </a:ext>
            </a:extLst>
          </p:cNvPr>
          <p:cNvCxnSpPr/>
          <p:nvPr/>
        </p:nvCxnSpPr>
        <p:spPr>
          <a:xfrm flipH="1">
            <a:off x="5907438" y="261186"/>
            <a:ext cx="0" cy="21031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078DC73C-2227-FC4B-882A-7BCFF9692CB1}"/>
              </a:ext>
            </a:extLst>
          </p:cNvPr>
          <p:cNvSpPr txBox="1"/>
          <p:nvPr/>
        </p:nvSpPr>
        <p:spPr>
          <a:xfrm>
            <a:off x="3893774" y="364546"/>
            <a:ext cx="9252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677G (E226G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CF84F36-BC0A-EB42-92F8-74C31B45C133}"/>
              </a:ext>
            </a:extLst>
          </p:cNvPr>
          <p:cNvSpPr txBox="1"/>
          <p:nvPr/>
        </p:nvSpPr>
        <p:spPr>
          <a:xfrm>
            <a:off x="4322494" y="515343"/>
            <a:ext cx="9012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946T (P316S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B2B9C01-C91C-3C4B-9EC4-9140C934DF07}"/>
              </a:ext>
            </a:extLst>
          </p:cNvPr>
          <p:cNvSpPr txBox="1"/>
          <p:nvPr/>
        </p:nvSpPr>
        <p:spPr>
          <a:xfrm>
            <a:off x="5016259" y="346258"/>
            <a:ext cx="9813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1688T (W563L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9F64A54-7B2D-A546-8001-9E28476619D8}"/>
              </a:ext>
            </a:extLst>
          </p:cNvPr>
          <p:cNvSpPr txBox="1"/>
          <p:nvPr/>
        </p:nvSpPr>
        <p:spPr>
          <a:xfrm>
            <a:off x="5830474" y="432887"/>
            <a:ext cx="9701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1925C (S642T)</a:t>
            </a:r>
          </a:p>
        </p:txBody>
      </p:sp>
      <p:graphicFrame>
        <p:nvGraphicFramePr>
          <p:cNvPr id="19" name="Chart 18">
            <a:extLst>
              <a:ext uri="{FF2B5EF4-FFF2-40B4-BE49-F238E27FC236}">
                <a16:creationId xmlns:a16="http://schemas.microsoft.com/office/drawing/2014/main" id="{573C2E8C-512A-7A41-8FCD-E72DB74DA01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77246059"/>
              </p:ext>
            </p:extLst>
          </p:nvPr>
        </p:nvGraphicFramePr>
        <p:xfrm>
          <a:off x="130251" y="819666"/>
          <a:ext cx="2432304" cy="20665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0" name="Chart 19">
            <a:extLst>
              <a:ext uri="{FF2B5EF4-FFF2-40B4-BE49-F238E27FC236}">
                <a16:creationId xmlns:a16="http://schemas.microsoft.com/office/drawing/2014/main" id="{7011157D-1A4B-504A-A70A-EDCB1472B27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720521"/>
              </p:ext>
            </p:extLst>
          </p:nvPr>
        </p:nvGraphicFramePr>
        <p:xfrm>
          <a:off x="5288903" y="819666"/>
          <a:ext cx="2432304" cy="20665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1" name="Chart 20">
            <a:extLst>
              <a:ext uri="{FF2B5EF4-FFF2-40B4-BE49-F238E27FC236}">
                <a16:creationId xmlns:a16="http://schemas.microsoft.com/office/drawing/2014/main" id="{C33058C5-D921-6B4E-8B90-3DB2714B66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42805603"/>
              </p:ext>
            </p:extLst>
          </p:nvPr>
        </p:nvGraphicFramePr>
        <p:xfrm>
          <a:off x="2709577" y="819666"/>
          <a:ext cx="2432304" cy="20665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2" name="Chart 21">
            <a:extLst>
              <a:ext uri="{FF2B5EF4-FFF2-40B4-BE49-F238E27FC236}">
                <a16:creationId xmlns:a16="http://schemas.microsoft.com/office/drawing/2014/main" id="{710C7C92-9065-CE4F-8862-EE896802EF9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1479655"/>
              </p:ext>
            </p:extLst>
          </p:nvPr>
        </p:nvGraphicFramePr>
        <p:xfrm>
          <a:off x="7868229" y="819666"/>
          <a:ext cx="2432304" cy="20665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3" name="TextBox 22">
            <a:extLst>
              <a:ext uri="{FF2B5EF4-FFF2-40B4-BE49-F238E27FC236}">
                <a16:creationId xmlns:a16="http://schemas.microsoft.com/office/drawing/2014/main" id="{456353A8-2407-504B-A7C7-8C55ACDF4A8C}"/>
              </a:ext>
            </a:extLst>
          </p:cNvPr>
          <p:cNvSpPr txBox="1"/>
          <p:nvPr/>
        </p:nvSpPr>
        <p:spPr>
          <a:xfrm rot="16200000">
            <a:off x="-824710" y="1561706"/>
            <a:ext cx="18318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charset="0"/>
                <a:ea typeface="Arial" charset="0"/>
                <a:cs typeface="Arial" charset="0"/>
              </a:rPr>
              <a:t>Allelic expression frequency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5093680-0B06-8A4F-8B45-27F73D1917A9}"/>
              </a:ext>
            </a:extLst>
          </p:cNvPr>
          <p:cNvSpPr txBox="1"/>
          <p:nvPr/>
        </p:nvSpPr>
        <p:spPr>
          <a:xfrm rot="16200000">
            <a:off x="1763583" y="1561706"/>
            <a:ext cx="18318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charset="0"/>
                <a:ea typeface="Arial" charset="0"/>
                <a:cs typeface="Arial" charset="0"/>
              </a:rPr>
              <a:t>Allelic expression frequency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56C641D-EFA9-E14E-B1A2-616085AAADF3}"/>
              </a:ext>
            </a:extLst>
          </p:cNvPr>
          <p:cNvSpPr txBox="1"/>
          <p:nvPr/>
        </p:nvSpPr>
        <p:spPr>
          <a:xfrm rot="16200000">
            <a:off x="4342317" y="1561706"/>
            <a:ext cx="18318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charset="0"/>
                <a:ea typeface="Arial" charset="0"/>
                <a:cs typeface="Arial" charset="0"/>
              </a:rPr>
              <a:t>Allelic expression frequency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E35FF41-9A38-1A47-A47B-33AD4E11D0C5}"/>
              </a:ext>
            </a:extLst>
          </p:cNvPr>
          <p:cNvSpPr txBox="1"/>
          <p:nvPr/>
        </p:nvSpPr>
        <p:spPr>
          <a:xfrm rot="16200000">
            <a:off x="6899879" y="1561706"/>
            <a:ext cx="18318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charset="0"/>
                <a:ea typeface="Arial" charset="0"/>
                <a:cs typeface="Arial" charset="0"/>
              </a:rPr>
              <a:t>Allelic expression frequency 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EDBC514E-12C7-4945-8C1C-7719B4C9B7D5}"/>
              </a:ext>
            </a:extLst>
          </p:cNvPr>
          <p:cNvCxnSpPr>
            <a:cxnSpLocks/>
            <a:stCxn id="15" idx="2"/>
            <a:endCxn id="19" idx="0"/>
          </p:cNvCxnSpPr>
          <p:nvPr/>
        </p:nvCxnSpPr>
        <p:spPr>
          <a:xfrm flipH="1">
            <a:off x="1346403" y="579990"/>
            <a:ext cx="3009998" cy="239676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3BE7E896-7F97-A446-AD6D-03E2A04AE1DB}"/>
              </a:ext>
            </a:extLst>
          </p:cNvPr>
          <p:cNvCxnSpPr>
            <a:cxnSpLocks/>
            <a:stCxn id="16" idx="2"/>
            <a:endCxn id="21" idx="0"/>
          </p:cNvCxnSpPr>
          <p:nvPr/>
        </p:nvCxnSpPr>
        <p:spPr>
          <a:xfrm flipH="1">
            <a:off x="3925729" y="730787"/>
            <a:ext cx="847370" cy="88879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84F56109-E369-9244-B4A3-5B03C6B6CA61}"/>
              </a:ext>
            </a:extLst>
          </p:cNvPr>
          <p:cNvCxnSpPr>
            <a:cxnSpLocks/>
            <a:endCxn id="20" idx="0"/>
          </p:cNvCxnSpPr>
          <p:nvPr/>
        </p:nvCxnSpPr>
        <p:spPr>
          <a:xfrm>
            <a:off x="5689208" y="561702"/>
            <a:ext cx="815847" cy="257964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7420E03D-354C-5445-AEB0-A7AA0DBCC4EE}"/>
              </a:ext>
            </a:extLst>
          </p:cNvPr>
          <p:cNvCxnSpPr>
            <a:cxnSpLocks/>
            <a:stCxn id="18" idx="3"/>
            <a:endCxn id="22" idx="0"/>
          </p:cNvCxnSpPr>
          <p:nvPr/>
        </p:nvCxnSpPr>
        <p:spPr>
          <a:xfrm>
            <a:off x="6800611" y="540609"/>
            <a:ext cx="2283770" cy="279057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Rectangle 61">
            <a:extLst>
              <a:ext uri="{FF2B5EF4-FFF2-40B4-BE49-F238E27FC236}">
                <a16:creationId xmlns:a16="http://schemas.microsoft.com/office/drawing/2014/main" id="{0A84067E-6310-9848-929A-0060F7DE31F1}"/>
              </a:ext>
            </a:extLst>
          </p:cNvPr>
          <p:cNvSpPr>
            <a:spLocks noChangeAspect="1"/>
          </p:cNvSpPr>
          <p:nvPr/>
        </p:nvSpPr>
        <p:spPr>
          <a:xfrm>
            <a:off x="569296" y="460194"/>
            <a:ext cx="137584" cy="137160"/>
          </a:xfrm>
          <a:prstGeom prst="rect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9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1FA86FE2-082E-5447-8EE0-84A8E3C0FCF1}"/>
              </a:ext>
            </a:extLst>
          </p:cNvPr>
          <p:cNvSpPr>
            <a:spLocks noChangeAspect="1"/>
          </p:cNvSpPr>
          <p:nvPr/>
        </p:nvSpPr>
        <p:spPr>
          <a:xfrm>
            <a:off x="569296" y="673515"/>
            <a:ext cx="137584" cy="13716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9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4D1EA99D-92F2-F945-AD75-5C834708DEF1}"/>
              </a:ext>
            </a:extLst>
          </p:cNvPr>
          <p:cNvSpPr txBox="1"/>
          <p:nvPr/>
        </p:nvSpPr>
        <p:spPr>
          <a:xfrm>
            <a:off x="676588" y="421052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ALS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7A6683AB-BAB7-004A-ADDC-AFBBF039DD4E}"/>
              </a:ext>
            </a:extLst>
          </p:cNvPr>
          <p:cNvSpPr txBox="1"/>
          <p:nvPr/>
        </p:nvSpPr>
        <p:spPr>
          <a:xfrm>
            <a:off x="676590" y="634373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mALS1</a:t>
            </a:r>
          </a:p>
        </p:txBody>
      </p:sp>
      <p:sp>
        <p:nvSpPr>
          <p:cNvPr id="48" name="Right Arrow 47">
            <a:extLst>
              <a:ext uri="{FF2B5EF4-FFF2-40B4-BE49-F238E27FC236}">
                <a16:creationId xmlns:a16="http://schemas.microsoft.com/office/drawing/2014/main" id="{C8343D7F-0990-F942-880A-0B0849A35E9A}"/>
              </a:ext>
            </a:extLst>
          </p:cNvPr>
          <p:cNvSpPr/>
          <p:nvPr/>
        </p:nvSpPr>
        <p:spPr>
          <a:xfrm>
            <a:off x="3514671" y="35001"/>
            <a:ext cx="3148486" cy="278174"/>
          </a:xfrm>
          <a:prstGeom prst="rightArrow">
            <a:avLst>
              <a:gd name="adj1" fmla="val 7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ALS1 </a:t>
            </a:r>
            <a:r>
              <a:rPr 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gene</a:t>
            </a:r>
            <a:endParaRPr lang="en-US" sz="800" i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87723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33</Words>
  <Application>Microsoft Macintosh PowerPoint</Application>
  <PresentationFormat>Custom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e Kwan Ko</dc:creator>
  <cp:lastModifiedBy>Dae Kwan Ko</cp:lastModifiedBy>
  <cp:revision>6</cp:revision>
  <dcterms:created xsi:type="dcterms:W3CDTF">2018-07-30T21:06:04Z</dcterms:created>
  <dcterms:modified xsi:type="dcterms:W3CDTF">2018-07-30T22:11:37Z</dcterms:modified>
</cp:coreProperties>
</file>